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BB0310-F2CD-4DC8-ADAF-5627EF6601C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020677-D076-467F-BC03-1F639919796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03262-8071-4343-ABC8-60F80EB33B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9D8760-5497-4CCC-AC5E-9DCD3CDD47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448502-3040-4F8A-8422-C25AEFC527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92218F-6232-495F-A227-F901460C42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6F2D9F-86A4-47A5-A793-66081D140C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2FEB12-C160-4497-8EEE-C68631F71F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15711C-A6D2-44F9-8B0F-9EA06F78E1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7C0D15-A5D4-4EFD-A4BE-B9F791809E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24D597-1480-412D-9442-06EE5C7FD0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83939F-4083-48CC-A8C6-C2BCB7B852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AD725-BEB4-40B1-8124-C8F9F141BE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D6186E-8DD3-479A-A4F6-C32A053C17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7C47A8-D53F-4D7B-92CD-9B2112161EE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2195640" y="5475240"/>
          <a:ext cx="4305240" cy="762120"/>
        </p:xfrm>
        <a:graphic>
          <a:graphicData uri="http://schemas.openxmlformats.org/drawingml/2006/table">
            <a:tbl>
              <a:tblPr/>
              <a:tblGrid>
                <a:gridCol w="779400"/>
                <a:gridCol w="576360"/>
                <a:gridCol w="574560"/>
                <a:gridCol w="576360"/>
                <a:gridCol w="900000"/>
                <a:gridCol w="898560"/>
              </a:tblGrid>
              <a:tr h="190440">
                <a:tc rowSpan="2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U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Erro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% Confidence Interva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0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wer Bou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pper Bou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GO scor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5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5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6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API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6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6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7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49" name="Group 7"/>
          <p:cNvGrpSpPr/>
          <p:nvPr/>
        </p:nvGrpSpPr>
        <p:grpSpPr>
          <a:xfrm>
            <a:off x="250920" y="1916280"/>
            <a:ext cx="8383320" cy="3241440"/>
            <a:chOff x="250920" y="1916280"/>
            <a:chExt cx="8383320" cy="3241440"/>
          </a:xfrm>
        </p:grpSpPr>
        <p:pic>
          <p:nvPicPr>
            <p:cNvPr id="50" name="Picture 2" descr=""/>
            <p:cNvPicPr/>
            <p:nvPr/>
          </p:nvPicPr>
          <p:blipFill>
            <a:blip r:embed="rId1"/>
            <a:srcRect l="0" t="0" r="0" b="6524"/>
            <a:stretch/>
          </p:blipFill>
          <p:spPr>
            <a:xfrm>
              <a:off x="250920" y="2060280"/>
              <a:ext cx="4134240" cy="309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3" descr=""/>
            <p:cNvPicPr/>
            <p:nvPr/>
          </p:nvPicPr>
          <p:blipFill>
            <a:blip r:embed="rId2"/>
            <a:srcRect l="0" t="0" r="0" b="6524"/>
            <a:stretch/>
          </p:blipFill>
          <p:spPr>
            <a:xfrm>
              <a:off x="4500000" y="2060280"/>
              <a:ext cx="4134240" cy="3097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Box 4"/>
            <p:cNvSpPr/>
            <p:nvPr/>
          </p:nvSpPr>
          <p:spPr>
            <a:xfrm>
              <a:off x="1848240" y="1916280"/>
              <a:ext cx="1206360" cy="36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y-GB" sz="1800" spc="-1" strike="noStrike">
                  <a:solidFill>
                    <a:srgbClr val="000000"/>
                  </a:solidFill>
                  <a:latin typeface="Calibri"/>
                </a:rPr>
                <a:t>FIGO Score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5"/>
            <p:cNvSpPr/>
            <p:nvPr/>
          </p:nvSpPr>
          <p:spPr>
            <a:xfrm>
              <a:off x="6240600" y="1916280"/>
              <a:ext cx="635040" cy="36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y-GB" sz="1800" spc="-1" strike="noStrike">
                  <a:solidFill>
                    <a:srgbClr val="000000"/>
                  </a:solidFill>
                  <a:latin typeface="Calibri"/>
                </a:rPr>
                <a:t>UAPI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4" name="TextBox 3"/>
          <p:cNvSpPr/>
          <p:nvPr/>
        </p:nvSpPr>
        <p:spPr>
          <a:xfrm>
            <a:off x="611280" y="692280"/>
            <a:ext cx="8153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upplementary Figure 1. Receiver operating characteristics curve (ROC) for FIGO prognostic score and UAPI for prediction of MTX-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y-GB" sz="1600" spc="-1" strike="noStrike">
                <a:solidFill>
                  <a:srgbClr val="000000"/>
                </a:solidFill>
                <a:latin typeface="Calibri"/>
              </a:rPr>
              <a:t>(ROC curves have been plotted for MTX-R risk as FIGO score increases and UAPI decreases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Rectangle 3"/>
          <p:cNvSpPr/>
          <p:nvPr/>
        </p:nvSpPr>
        <p:spPr>
          <a:xfrm>
            <a:off x="304920" y="925560"/>
            <a:ext cx="8534160" cy="301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haring Cross Hospital Indications for chemotherapy in gestational trophoblastic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disease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Histological evidence of choriocarcinom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Evidence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of metastases in brain, liver, or gastrointestinal tract, o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radiological opacities &gt;2 cm on chest radiograph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Pulmonary,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vulval, or vaginal metastases unless human chorionic gonadotrophin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oncentrations are fall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Heavy vaginal bleeding or evidence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of gastrointestinal or intraperitoneal haemorrhage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Rising hCG concentrations in two consecutive sample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or plateaued concentrations in three consecutive samples afte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   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    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evacuation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Serum hCG greater than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20 000 IU/l more than four weeks after evacuation, because of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the risk of uterine perfor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Raised hCG concentrations six months after evacuation, even if still fall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"/>
          <p:cNvSpPr/>
          <p:nvPr/>
        </p:nvSpPr>
        <p:spPr>
          <a:xfrm>
            <a:off x="304920" y="4098960"/>
            <a:ext cx="853416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O 2000 Criteria for the diagnosis of post hydatidiform mole GT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lateau of hCG lasts for 4 measurements over a period of 3 weeks or longer, that is days 1,7,14,2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ise of hCG on three consecutive weekly measurements, over a period of two weeks or longer, days 1,7,14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istologic diagnosis of choriocarcinom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CG level remains elevated for 6 months or mor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3"/>
          <p:cNvSpPr/>
          <p:nvPr/>
        </p:nvSpPr>
        <p:spPr>
          <a:xfrm>
            <a:off x="304920" y="343080"/>
            <a:ext cx="815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ry Table 1. Charing Cross Hospital Indications for Chemotherapy and FIGO 2000 Criteria for diagnosis of GT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Straight Connector 5"/>
          <p:cNvSpPr/>
          <p:nvPr/>
        </p:nvSpPr>
        <p:spPr>
          <a:xfrm>
            <a:off x="304920" y="4037040"/>
            <a:ext cx="8534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Straight Connector 7"/>
          <p:cNvSpPr/>
          <p:nvPr/>
        </p:nvSpPr>
        <p:spPr>
          <a:xfrm>
            <a:off x="304920" y="5916600"/>
            <a:ext cx="8534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Straight Connector 8"/>
          <p:cNvSpPr/>
          <p:nvPr/>
        </p:nvSpPr>
        <p:spPr>
          <a:xfrm>
            <a:off x="304920" y="874800"/>
            <a:ext cx="85341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9"/>
          <p:cNvSpPr/>
          <p:nvPr/>
        </p:nvSpPr>
        <p:spPr>
          <a:xfrm>
            <a:off x="304920" y="6105600"/>
            <a:ext cx="8534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GTN – gestational throphoblastic neoplasm, hCG – human chorionic gonadotrophi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1028" descr=""/>
          <p:cNvPicPr/>
          <p:nvPr/>
        </p:nvPicPr>
        <p:blipFill>
          <a:blip r:embed="rId1"/>
          <a:srcRect l="618" t="797" r="777" b="1060"/>
          <a:stretch/>
        </p:blipFill>
        <p:spPr>
          <a:xfrm>
            <a:off x="982800" y="1603440"/>
            <a:ext cx="7313400" cy="4249800"/>
          </a:xfrm>
          <a:prstGeom prst="rect">
            <a:avLst/>
          </a:prstGeom>
          <a:ln w="0">
            <a:noFill/>
          </a:ln>
        </p:spPr>
      </p:pic>
      <p:sp>
        <p:nvSpPr>
          <p:cNvPr id="63" name="TextBox 3"/>
          <p:cNvSpPr/>
          <p:nvPr/>
        </p:nvSpPr>
        <p:spPr>
          <a:xfrm>
            <a:off x="900000" y="836640"/>
            <a:ext cx="81536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upplementary Table 2. FIGO prognostic scoring system for GT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y-GB" sz="1600" spc="-1" strike="noStrike">
                <a:solidFill>
                  <a:srgbClr val="000000"/>
                </a:solidFill>
                <a:latin typeface="Calibri"/>
              </a:rPr>
              <a:t>(Low risk: &lt;7; High risk ≥ 7 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06T15:21:36Z</dcterms:created>
  <dc:creator> </dc:creator>
  <dc:description/>
  <dc:language>en-US</dc:language>
  <cp:lastModifiedBy>shamantha</cp:lastModifiedBy>
  <dcterms:modified xsi:type="dcterms:W3CDTF">2012-02-21T07:34:27Z</dcterms:modified>
  <cp:revision>2</cp:revision>
  <dc:subject/>
  <dc:title>Slide 1</dc:title>
</cp:coreProperties>
</file>